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8"/>
  </p:notesMasterIdLst>
  <p:sldIdLst>
    <p:sldId id="261" r:id="rId5"/>
    <p:sldId id="270" r:id="rId6"/>
    <p:sldId id="27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32" userDrawn="1">
          <p15:clr>
            <a:srgbClr val="A4A3A4"/>
          </p15:clr>
        </p15:guide>
        <p15:guide id="2" pos="2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FBC9B0E-50EA-BE61-99D6-1F743DC619CC}" name="Zaid Al-Azzawi" initials="ZAA" userId="S::zaid.al.azzawi@alumni.utoronto.ca::3ec7c0a6-4b84-4c48-ac03-780672cb7a0a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sther" initials="e" lastIdx="1" clrIdx="0">
    <p:extLst>
      <p:ext uri="{19B8F6BF-5375-455C-9EA6-DF929625EA0E}">
        <p15:presenceInfo xmlns:p15="http://schemas.microsoft.com/office/powerpoint/2012/main" userId="esth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FF7D7D"/>
    <a:srgbClr val="02FF00"/>
    <a:srgbClr val="F4960C"/>
    <a:srgbClr val="F5A32B"/>
    <a:srgbClr val="0000FF"/>
    <a:srgbClr val="A1C6E7"/>
    <a:srgbClr val="4E93D2"/>
    <a:srgbClr val="F74B4B"/>
    <a:srgbClr val="FF21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492" autoAdjust="0"/>
    <p:restoredTop sz="82740"/>
  </p:normalViewPr>
  <p:slideViewPr>
    <p:cSldViewPr snapToGrid="0">
      <p:cViewPr varScale="1">
        <p:scale>
          <a:sx n="69" d="100"/>
          <a:sy n="69" d="100"/>
        </p:scale>
        <p:origin x="3696" y="200"/>
      </p:cViewPr>
      <p:guideLst>
        <p:guide orient="horz" pos="3732"/>
        <p:guide pos="2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Relationship Id="rId14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B4BC57-6739-3147-8AD3-17225C762BDA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C0798-BB55-9448-BEEE-AB24E423C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1507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1C0798-BB55-9448-BEEE-AB24E423CB3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0429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1C0798-BB55-9448-BEEE-AB24E423CB3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8803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1C0798-BB55-9448-BEEE-AB24E423CB3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6847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100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641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987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628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871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596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72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033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8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224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900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92DC9-BB13-49FF-A5F5-FE87F273EB2C}" type="datetimeFigureOut">
              <a:rPr lang="en-US" smtClean="0"/>
              <a:t>1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863B84-8264-4E07-ABB2-3E4C9B8419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77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2477233" y="297105"/>
            <a:ext cx="134524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/>
              <a:t>Supplemental Figure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739A421-D7A0-C989-C8C1-4ACDC14AD365}"/>
              </a:ext>
            </a:extLst>
          </p:cNvPr>
          <p:cNvSpPr txBox="1"/>
          <p:nvPr/>
        </p:nvSpPr>
        <p:spPr>
          <a:xfrm>
            <a:off x="139849" y="839096"/>
            <a:ext cx="36327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Figure 1. Synuclein expression in </a:t>
            </a:r>
            <a:r>
              <a:rPr lang="en-US" sz="1000" b="1" dirty="0" err="1"/>
              <a:t>iPSc</a:t>
            </a:r>
            <a:r>
              <a:rPr lang="en-US" sz="1000" b="1" dirty="0"/>
              <a:t>-derived dopamine neurons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1C664683-0C07-83C6-F666-E53A8A9D17A5}"/>
              </a:ext>
            </a:extLst>
          </p:cNvPr>
          <p:cNvGrpSpPr/>
          <p:nvPr/>
        </p:nvGrpSpPr>
        <p:grpSpPr>
          <a:xfrm>
            <a:off x="219456" y="1298448"/>
            <a:ext cx="5659841" cy="3976141"/>
            <a:chOff x="544278" y="148865"/>
            <a:chExt cx="8455840" cy="7004199"/>
          </a:xfrm>
        </p:grpSpPr>
        <p:pic>
          <p:nvPicPr>
            <p:cNvPr id="2" name="Picture 1" descr="A close-up of a red and blue background&#10;&#10;Description automatically generated">
              <a:extLst>
                <a:ext uri="{FF2B5EF4-FFF2-40B4-BE49-F238E27FC236}">
                  <a16:creationId xmlns:a16="http://schemas.microsoft.com/office/drawing/2014/main" id="{868A7973-1C19-4E4E-7999-803A2780D7F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4279" y="148865"/>
              <a:ext cx="2038809" cy="2047850"/>
            </a:xfrm>
            <a:prstGeom prst="rect">
              <a:avLst/>
            </a:prstGeom>
          </p:spPr>
        </p:pic>
        <p:pic>
          <p:nvPicPr>
            <p:cNvPr id="4" name="Picture 3" descr="A green and blue glowing lines&#10;&#10;Description automatically generated with medium confidence">
              <a:extLst>
                <a:ext uri="{FF2B5EF4-FFF2-40B4-BE49-F238E27FC236}">
                  <a16:creationId xmlns:a16="http://schemas.microsoft.com/office/drawing/2014/main" id="{1FFBD940-0B5B-BFDA-A7CB-C172CFC73EC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01912" y="148865"/>
              <a:ext cx="2038810" cy="2047851"/>
            </a:xfrm>
            <a:prstGeom prst="rect">
              <a:avLst/>
            </a:prstGeom>
          </p:spPr>
        </p:pic>
        <p:pic>
          <p:nvPicPr>
            <p:cNvPr id="5" name="Picture 4" descr="A close-up of a neuron&#10;&#10;Description automatically generated">
              <a:extLst>
                <a:ext uri="{FF2B5EF4-FFF2-40B4-BE49-F238E27FC236}">
                  <a16:creationId xmlns:a16="http://schemas.microsoft.com/office/drawing/2014/main" id="{26C712F0-A0FA-9C4E-6A26-3CD9F76914B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59544" y="148865"/>
              <a:ext cx="2038810" cy="2047851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89FB115-9E45-8FAF-17A2-E0727CBDF3CA}"/>
                </a:ext>
              </a:extLst>
            </p:cNvPr>
            <p:cNvSpPr txBox="1"/>
            <p:nvPr/>
          </p:nvSpPr>
          <p:spPr>
            <a:xfrm>
              <a:off x="7257975" y="1169483"/>
              <a:ext cx="1742143" cy="59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Triplication</a:t>
              </a:r>
            </a:p>
          </p:txBody>
        </p:sp>
        <p:pic>
          <p:nvPicPr>
            <p:cNvPr id="7" name="Picture 6" descr="A close-up of a cluster of neurons&#10;&#10;Description automatically generated">
              <a:extLst>
                <a:ext uri="{FF2B5EF4-FFF2-40B4-BE49-F238E27FC236}">
                  <a16:creationId xmlns:a16="http://schemas.microsoft.com/office/drawing/2014/main" id="{40BDA8B9-2DC7-5453-6508-8989696CF7C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4278" y="2345963"/>
              <a:ext cx="2038810" cy="2047851"/>
            </a:xfrm>
            <a:prstGeom prst="rect">
              <a:avLst/>
            </a:prstGeom>
          </p:spPr>
        </p:pic>
        <p:pic>
          <p:nvPicPr>
            <p:cNvPr id="8" name="Picture 7" descr="A green and blue background with many dots&#10;&#10;Description automatically generated with medium confidence">
              <a:extLst>
                <a:ext uri="{FF2B5EF4-FFF2-40B4-BE49-F238E27FC236}">
                  <a16:creationId xmlns:a16="http://schemas.microsoft.com/office/drawing/2014/main" id="{CFEBC90B-0A73-45A0-686D-CB12B12B694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801910" y="2340128"/>
              <a:ext cx="2038810" cy="2047851"/>
            </a:xfrm>
            <a:prstGeom prst="rect">
              <a:avLst/>
            </a:prstGeom>
          </p:spPr>
        </p:pic>
        <p:pic>
          <p:nvPicPr>
            <p:cNvPr id="9" name="Picture 8" descr="A close-up of a neuron&#10;&#10;Description automatically generated">
              <a:extLst>
                <a:ext uri="{FF2B5EF4-FFF2-40B4-BE49-F238E27FC236}">
                  <a16:creationId xmlns:a16="http://schemas.microsoft.com/office/drawing/2014/main" id="{028F71CD-33CA-0D21-7BFA-61A5AAD7255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56997" y="2340128"/>
              <a:ext cx="2038810" cy="204785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929DC08-ED39-F825-1463-68F55C7B3108}"/>
                </a:ext>
              </a:extLst>
            </p:cNvPr>
            <p:cNvSpPr txBox="1"/>
            <p:nvPr/>
          </p:nvSpPr>
          <p:spPr>
            <a:xfrm>
              <a:off x="7257975" y="3244333"/>
              <a:ext cx="1415863" cy="59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sogenic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A0737D7-0D05-4ACF-AAF2-1E8C526B4D6A}"/>
                </a:ext>
              </a:extLst>
            </p:cNvPr>
            <p:cNvSpPr txBox="1"/>
            <p:nvPr/>
          </p:nvSpPr>
          <p:spPr>
            <a:xfrm>
              <a:off x="1184221" y="6555496"/>
              <a:ext cx="881004" cy="59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95BC638-A7E5-7288-F195-4709D9EA41B3}"/>
                </a:ext>
              </a:extLst>
            </p:cNvPr>
            <p:cNvSpPr txBox="1"/>
            <p:nvPr/>
          </p:nvSpPr>
          <p:spPr>
            <a:xfrm>
              <a:off x="3401360" y="6524468"/>
              <a:ext cx="876977" cy="59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y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51E9325-5C0B-4039-95FB-2270FBB22DBA}"/>
                </a:ext>
              </a:extLst>
            </p:cNvPr>
            <p:cNvSpPr txBox="1"/>
            <p:nvPr/>
          </p:nvSpPr>
          <p:spPr>
            <a:xfrm>
              <a:off x="4998182" y="6556682"/>
              <a:ext cx="2215758" cy="59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600" dirty="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16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yn</a:t>
              </a:r>
            </a:p>
          </p:txBody>
        </p:sp>
        <p:pic>
          <p:nvPicPr>
            <p:cNvPr id="14" name="Content Placeholder 5" descr="A close-up of a red and blue background&#10;&#10;Description automatically generated">
              <a:extLst>
                <a:ext uri="{FF2B5EF4-FFF2-40B4-BE49-F238E27FC236}">
                  <a16:creationId xmlns:a16="http://schemas.microsoft.com/office/drawing/2014/main" id="{917BEA14-1851-0191-61B3-6F85993301E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44278" y="4530363"/>
              <a:ext cx="2038810" cy="2047851"/>
            </a:xfrm>
            <a:prstGeom prst="rect">
              <a:avLst/>
            </a:prstGeom>
          </p:spPr>
        </p:pic>
        <p:pic>
          <p:nvPicPr>
            <p:cNvPr id="16" name="Picture 15" descr="A blue lights in the sky&#10;&#10;Description automatically generated">
              <a:extLst>
                <a:ext uri="{FF2B5EF4-FFF2-40B4-BE49-F238E27FC236}">
                  <a16:creationId xmlns:a16="http://schemas.microsoft.com/office/drawing/2014/main" id="{69F8FF71-147E-0C50-849A-30DC4773715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801909" y="4530362"/>
              <a:ext cx="2038810" cy="2047851"/>
            </a:xfrm>
            <a:prstGeom prst="rect">
              <a:avLst/>
            </a:prstGeom>
          </p:spPr>
        </p:pic>
        <p:pic>
          <p:nvPicPr>
            <p:cNvPr id="17" name="Picture 16" descr="A close-up of a nerve cell&#10;&#10;Description automatically generated">
              <a:extLst>
                <a:ext uri="{FF2B5EF4-FFF2-40B4-BE49-F238E27FC236}">
                  <a16:creationId xmlns:a16="http://schemas.microsoft.com/office/drawing/2014/main" id="{29D19D22-E06B-7550-B1F0-917C26283E7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056997" y="4530362"/>
              <a:ext cx="2038810" cy="2047851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6D05097-A0AF-BFA3-D666-BD5D4CCF75FF}"/>
                </a:ext>
              </a:extLst>
            </p:cNvPr>
            <p:cNvSpPr txBox="1"/>
            <p:nvPr/>
          </p:nvSpPr>
          <p:spPr>
            <a:xfrm>
              <a:off x="7257975" y="5319185"/>
              <a:ext cx="1552373" cy="59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Knockout</a:t>
              </a:r>
            </a:p>
          </p:txBody>
        </p:sp>
      </p:grpSp>
      <p:pic>
        <p:nvPicPr>
          <p:cNvPr id="21" name="Picture 20" descr="A graph of a number of neurons&#10;&#10;AI-generated content may be incorrect.">
            <a:extLst>
              <a:ext uri="{FF2B5EF4-FFF2-40B4-BE49-F238E27FC236}">
                <a16:creationId xmlns:a16="http://schemas.microsoft.com/office/drawing/2014/main" id="{505FFFCC-6261-E171-0383-790CEFD32E6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3689" y="5745994"/>
            <a:ext cx="3373373" cy="40280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80290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9DBBECD-DCA3-AC20-C22C-9D75B2FBD021}"/>
              </a:ext>
            </a:extLst>
          </p:cNvPr>
          <p:cNvSpPr txBox="1"/>
          <p:nvPr/>
        </p:nvSpPr>
        <p:spPr>
          <a:xfrm>
            <a:off x="0" y="0"/>
            <a:ext cx="23097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Table 1. </a:t>
            </a:r>
          </a:p>
        </p:txBody>
      </p:sp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8E136033-C3C6-D9C3-7CC5-40BDB8DAFB3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74315670"/>
              </p:ext>
            </p:extLst>
          </p:nvPr>
        </p:nvGraphicFramePr>
        <p:xfrm>
          <a:off x="690014" y="827083"/>
          <a:ext cx="5744672" cy="628492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728719">
                  <a:extLst>
                    <a:ext uri="{9D8B030D-6E8A-4147-A177-3AD203B41FA5}">
                      <a16:colId xmlns:a16="http://schemas.microsoft.com/office/drawing/2014/main" val="1668487348"/>
                    </a:ext>
                  </a:extLst>
                </a:gridCol>
                <a:gridCol w="1580934">
                  <a:extLst>
                    <a:ext uri="{9D8B030D-6E8A-4147-A177-3AD203B41FA5}">
                      <a16:colId xmlns:a16="http://schemas.microsoft.com/office/drawing/2014/main" val="3259207097"/>
                    </a:ext>
                  </a:extLst>
                </a:gridCol>
                <a:gridCol w="1435019">
                  <a:extLst>
                    <a:ext uri="{9D8B030D-6E8A-4147-A177-3AD203B41FA5}">
                      <a16:colId xmlns:a16="http://schemas.microsoft.com/office/drawing/2014/main" val="1989571373"/>
                    </a:ext>
                  </a:extLst>
                </a:gridCol>
              </a:tblGrid>
              <a:tr h="146161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Midbrain Neural Progenitor Induction Media (NPC Induction Media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2793256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mponen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upplier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ncentratio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014701123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DMEM/F1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717746588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B-2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917835604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-2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3684145558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MEM nonessential amino acid (NEAA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Wisent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689226168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HIR-99021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elleckchem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3 μ</a:t>
                      </a:r>
                      <a:r>
                        <a:rPr lang="en-CA" sz="800">
                          <a:effectLst/>
                        </a:rPr>
                        <a:t>M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879296660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FGF-8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Peprotech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00 ng/mL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892492897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oggin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Peprotech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200 ng/mL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33558121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B431542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elleckchem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10 μ</a:t>
                      </a:r>
                      <a:r>
                        <a:rPr lang="en-CA" sz="800">
                          <a:effectLst/>
                        </a:rPr>
                        <a:t>M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532902022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onic hedgehog (SHH; C24II)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enScript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200 ng/mL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3753771001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Antibiotic-Antimycotic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902448109"/>
                  </a:ext>
                </a:extLst>
              </a:tr>
              <a:tr h="146161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PC Maintenance Medi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2459583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mponen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upplier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ncentratio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3219322806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DMEM/F1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765246251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B-2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213030158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-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566197265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MEM nonessential amino acid (NEAA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Wisent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911197403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Purmorphamin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temCell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601168333"/>
                  </a:ext>
                </a:extLst>
              </a:tr>
              <a:tr h="146161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Dopaminergic differentiation medi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6901997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mponen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upplier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ncentratio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455208091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eurobasal medi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4007269284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BrainPhys Neuronal Medi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temCell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3143978385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B-2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3941335878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-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ibco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826244548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Ascorbic acid (AA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igm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200 μ</a:t>
                      </a:r>
                      <a:r>
                        <a:rPr lang="en-CA" sz="800">
                          <a:effectLst/>
                        </a:rPr>
                        <a:t>M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3398543584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BDNF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Peprotech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20 ng/mL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481150207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mpound E (</a:t>
                      </a:r>
                      <a:r>
                        <a:rPr lang="el-GR" sz="800">
                          <a:effectLst/>
                        </a:rPr>
                        <a:t>γ-</a:t>
                      </a:r>
                      <a:r>
                        <a:rPr lang="en-CA" sz="800">
                          <a:effectLst/>
                        </a:rPr>
                        <a:t>secretase inhibitor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TEMCELL Technologies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0.1 μ</a:t>
                      </a:r>
                      <a:r>
                        <a:rPr lang="en-CA" sz="800">
                          <a:effectLst/>
                        </a:rPr>
                        <a:t>M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905483261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db-cAMP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arbosynth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0.5 mM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209136192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DNF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Peprotech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20 ng/mL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996905225"/>
                  </a:ext>
                </a:extLst>
              </a:tr>
              <a:tr h="146161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iPSC Culture Reagents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1159267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mponen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upplier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ncentratio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273695059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Matrigel 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rning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641985929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mTeSR Medium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temCell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74067198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ReLeSR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temCell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307769495"/>
                  </a:ext>
                </a:extLst>
              </a:tr>
              <a:tr h="146161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Other Reagents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9082276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mponen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upplier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oncentratio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118601173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Y-27632 (ROCK inhibitor)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elleckchem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10 μ</a:t>
                      </a:r>
                      <a:r>
                        <a:rPr lang="en-CA" sz="800">
                          <a:effectLst/>
                        </a:rPr>
                        <a:t>M 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809315233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MitomycinC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igm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1 μ</a:t>
                      </a:r>
                      <a:r>
                        <a:rPr lang="en-CA" sz="800">
                          <a:effectLst/>
                        </a:rPr>
                        <a:t>g/mL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690085288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Laminin 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igm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Culture vessel coating: 5 </a:t>
                      </a:r>
                      <a:r>
                        <a:rPr lang="el-GR" sz="800">
                          <a:effectLst/>
                        </a:rPr>
                        <a:t>μ</a:t>
                      </a:r>
                      <a:r>
                        <a:rPr lang="en-CA" sz="800">
                          <a:effectLst/>
                        </a:rPr>
                        <a:t>g/mL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674004524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Poly-L-ornithine(PO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igma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10 μ</a:t>
                      </a:r>
                      <a:r>
                        <a:rPr lang="en-CA" sz="800">
                          <a:effectLst/>
                        </a:rPr>
                        <a:t>g/mL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3620835704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temPro Accutase Cell Dissociation Reagen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Thermo-Fisher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X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1068181013"/>
                  </a:ext>
                </a:extLst>
              </a:tr>
              <a:tr h="14616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Gentle Cell Dissociation Reagen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TEMCELL Technologies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buNone/>
                      </a:pPr>
                      <a:r>
                        <a:rPr lang="en-CA" sz="800" dirty="0">
                          <a:effectLst/>
                        </a:rPr>
                        <a:t>1X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50" marR="5550" marT="5550" marB="0"/>
                </a:tc>
                <a:extLst>
                  <a:ext uri="{0D108BD9-81ED-4DB2-BD59-A6C34878D82A}">
                    <a16:rowId xmlns:a16="http://schemas.microsoft.com/office/drawing/2014/main" val="28312113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490974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BD46A50-6FC5-5652-F85E-089780DC1A25}"/>
              </a:ext>
            </a:extLst>
          </p:cNvPr>
          <p:cNvSpPr txBox="1"/>
          <p:nvPr/>
        </p:nvSpPr>
        <p:spPr>
          <a:xfrm>
            <a:off x="0" y="0"/>
            <a:ext cx="23097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Table 2 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CBB5E69-6C7A-145A-6B71-D89873399D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2563479"/>
              </p:ext>
            </p:extLst>
          </p:nvPr>
        </p:nvGraphicFramePr>
        <p:xfrm>
          <a:off x="490538" y="597694"/>
          <a:ext cx="5915025" cy="4267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166904">
                  <a:extLst>
                    <a:ext uri="{9D8B030D-6E8A-4147-A177-3AD203B41FA5}">
                      <a16:colId xmlns:a16="http://schemas.microsoft.com/office/drawing/2014/main" val="4172342346"/>
                    </a:ext>
                  </a:extLst>
                </a:gridCol>
                <a:gridCol w="1778057">
                  <a:extLst>
                    <a:ext uri="{9D8B030D-6E8A-4147-A177-3AD203B41FA5}">
                      <a16:colId xmlns:a16="http://schemas.microsoft.com/office/drawing/2014/main" val="2220089187"/>
                    </a:ext>
                  </a:extLst>
                </a:gridCol>
                <a:gridCol w="970064">
                  <a:extLst>
                    <a:ext uri="{9D8B030D-6E8A-4147-A177-3AD203B41FA5}">
                      <a16:colId xmlns:a16="http://schemas.microsoft.com/office/drawing/2014/main" val="1661401829"/>
                    </a:ext>
                  </a:extLst>
                </a:gridCol>
              </a:tblGrid>
              <a:tr h="203200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Immunofluorescenc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190077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ame/Targe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upplier/Cat#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Dilution use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7572850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Microtubule-associated protein (Map2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Encor, CPCA-MAP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2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1657519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Tyrosine hydroxylase (TH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Pelfreeze, P40101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5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545067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α-</a:t>
                      </a:r>
                      <a:r>
                        <a:rPr lang="en-CA" sz="800">
                          <a:effectLst/>
                        </a:rPr>
                        <a:t>synuclein (</a:t>
                      </a:r>
                      <a:r>
                        <a:rPr lang="el-GR" sz="800">
                          <a:effectLst/>
                        </a:rPr>
                        <a:t>α-</a:t>
                      </a:r>
                      <a:r>
                        <a:rPr lang="en-CA" sz="800">
                          <a:effectLst/>
                        </a:rPr>
                        <a:t>syn SYN1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BD Biosciences, 61078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1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9357787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129 phosphorylated </a:t>
                      </a:r>
                      <a:r>
                        <a:rPr lang="el-GR" sz="800">
                          <a:effectLst/>
                        </a:rPr>
                        <a:t>α-</a:t>
                      </a:r>
                      <a:r>
                        <a:rPr lang="en-CA" sz="800">
                          <a:effectLst/>
                        </a:rPr>
                        <a:t>synuclein (pSyn-S129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Abcam, ab51253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1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1987957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Phalloidin:TRITC 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ECM biosciences, PF7551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5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593968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Hoechst 3334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Fisher, H357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10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436897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Ab-Heparan sulfate (F58-10E4)(HSPG) 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Amsbio, 370255-S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1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4011690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Wheat Germ Agglutinin (WGA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Thermo, W32466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1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71061543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CA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6525108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Immunohistochemistry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5654094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ame/Targe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upplier/Cat#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Dilution use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9139915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129 phosphorylated </a:t>
                      </a:r>
                      <a:r>
                        <a:rPr lang="el-GR" sz="800">
                          <a:effectLst/>
                        </a:rPr>
                        <a:t>α-</a:t>
                      </a:r>
                      <a:r>
                        <a:rPr lang="en-CA" sz="800">
                          <a:effectLst/>
                        </a:rPr>
                        <a:t>synuclein (pSyn-S129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Abcam, ab184674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1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8764389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Tyrosine hydroxylase (TH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Pelfreeze, P40101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5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41738645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CA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803767"/>
                  </a:ext>
                </a:extLst>
              </a:tr>
              <a:tr h="203200"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Western Blo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902655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Name/Target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Supplier/Cat#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Dilution use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702231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α-</a:t>
                      </a:r>
                      <a:r>
                        <a:rPr lang="en-CA" sz="800">
                          <a:effectLst/>
                        </a:rPr>
                        <a:t>synuclein (</a:t>
                      </a:r>
                      <a:r>
                        <a:rPr lang="el-GR" sz="800">
                          <a:effectLst/>
                        </a:rPr>
                        <a:t>α-</a:t>
                      </a:r>
                      <a:r>
                        <a:rPr lang="en-CA" sz="800">
                          <a:effectLst/>
                        </a:rPr>
                        <a:t>syn SYN1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BD Biosciences, 61078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1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2117860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l-GR" sz="800">
                          <a:effectLst/>
                        </a:rPr>
                        <a:t>α-</a:t>
                      </a:r>
                      <a:r>
                        <a:rPr lang="en-CA" sz="800">
                          <a:effectLst/>
                        </a:rPr>
                        <a:t>synuclein (</a:t>
                      </a:r>
                      <a:r>
                        <a:rPr lang="el-GR" sz="800">
                          <a:effectLst/>
                        </a:rPr>
                        <a:t>α-</a:t>
                      </a:r>
                      <a:r>
                        <a:rPr lang="en-CA" sz="800">
                          <a:effectLst/>
                        </a:rPr>
                        <a:t>syn MJFR1)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Abcam, ab138501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1 in 10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9349458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Acti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>
                          <a:effectLst/>
                        </a:rPr>
                        <a:t>Millipore, MAB1501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en-CA" sz="800" dirty="0">
                          <a:effectLst/>
                        </a:rPr>
                        <a:t>1 in 10000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629153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14156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B1D3C675548CC4889C8ED90AD14629B" ma:contentTypeVersion="16" ma:contentTypeDescription="Create a new document." ma:contentTypeScope="" ma:versionID="23c0aa694b381ec2ea21193581324cc4">
  <xsd:schema xmlns:xsd="http://www.w3.org/2001/XMLSchema" xmlns:xs="http://www.w3.org/2001/XMLSchema" xmlns:p="http://schemas.microsoft.com/office/2006/metadata/properties" xmlns:ns2="3884131b-2c39-47e2-a3e4-3101854f1d5a" xmlns:ns3="5d25ea01-f85b-4b5f-9dc5-81277bee278c" targetNamespace="http://schemas.microsoft.com/office/2006/metadata/properties" ma:root="true" ma:fieldsID="824659d4be215b1f449679be46a80a71" ns2:_="" ns3:_="">
    <xsd:import namespace="3884131b-2c39-47e2-a3e4-3101854f1d5a"/>
    <xsd:import namespace="5d25ea01-f85b-4b5f-9dc5-81277bee278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MediaServiceLocation" minOccurs="0"/>
                <xsd:element ref="ns2:MediaServiceOCR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884131b-2c39-47e2-a3e4-3101854f1d5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2baaf764-73f0-4b4c-b8e1-b7d465e0804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6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3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d25ea01-f85b-4b5f-9dc5-81277bee278c" elementFormDefault="qualified">
    <xsd:import namespace="http://schemas.microsoft.com/office/2006/documentManagement/types"/>
    <xsd:import namespace="http://schemas.microsoft.com/office/infopath/2007/PartnerControls"/>
    <xsd:element name="SharedWithUsers" ma:index="1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a35e0819-8bee-45f7-bfaa-3a6d735c3807}" ma:internalName="TaxCatchAll" ma:showField="CatchAllData" ma:web="5d25ea01-f85b-4b5f-9dc5-81277bee278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884131b-2c39-47e2-a3e4-3101854f1d5a">
      <Terms xmlns="http://schemas.microsoft.com/office/infopath/2007/PartnerControls"/>
    </lcf76f155ced4ddcb4097134ff3c332f>
    <TaxCatchAll xmlns="5d25ea01-f85b-4b5f-9dc5-81277bee278c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920F463-B29E-4B1A-A742-4640550C1F1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884131b-2c39-47e2-a3e4-3101854f1d5a"/>
    <ds:schemaRef ds:uri="5d25ea01-f85b-4b5f-9dc5-81277bee278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CEDF950-14B7-4D1C-B9AD-4168C18A746B}">
  <ds:schemaRefs>
    <ds:schemaRef ds:uri="http://schemas.microsoft.com/office/2006/documentManagement/types"/>
    <ds:schemaRef ds:uri="http://purl.org/dc/elements/1.1/"/>
    <ds:schemaRef ds:uri="http://www.w3.org/XML/1998/namespace"/>
    <ds:schemaRef ds:uri="3884131b-2c39-47e2-a3e4-3101854f1d5a"/>
    <ds:schemaRef ds:uri="http://purl.org/dc/dcmitype/"/>
    <ds:schemaRef ds:uri="http://purl.org/dc/terms/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5d25ea01-f85b-4b5f-9dc5-81277bee278c"/>
  </ds:schemaRefs>
</ds:datastoreItem>
</file>

<file path=customXml/itemProps3.xml><?xml version="1.0" encoding="utf-8"?>
<ds:datastoreItem xmlns:ds="http://schemas.openxmlformats.org/officeDocument/2006/customXml" ds:itemID="{E7317438-D41E-4E4E-A404-E821C70D00E5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cd319671-52e7-4a68-afa9-fcf8f89f09ea}" enabled="0" method="" siteId="{cd319671-52e7-4a68-afa9-fcf8f89f09ea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976</TotalTime>
  <Words>441</Words>
  <Application>Microsoft Macintosh PowerPoint</Application>
  <PresentationFormat>A4 Paper (210x297 mm)</PresentationFormat>
  <Paragraphs>183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ther</dc:creator>
  <cp:lastModifiedBy>Zaid Al-Azzawi</cp:lastModifiedBy>
  <cp:revision>373</cp:revision>
  <dcterms:created xsi:type="dcterms:W3CDTF">2022-12-07T17:02:56Z</dcterms:created>
  <dcterms:modified xsi:type="dcterms:W3CDTF">2025-11-21T14:00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B1D3C675548CC4889C8ED90AD14629B</vt:lpwstr>
  </property>
  <property fmtid="{D5CDD505-2E9C-101B-9397-08002B2CF9AE}" pid="3" name="MediaServiceImageTags">
    <vt:lpwstr/>
  </property>
</Properties>
</file>